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A48CD0-E1FC-43DC-9CBE-73D19FEFC86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07D44-667E-4A04-AE6E-B729C816897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693615-24AE-4C94-BB6D-99C26D532C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3CAED3-0287-4DBA-AAF1-19674B70E5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FAC0A0-69F1-4788-A93E-6357944EED5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0F764B-CAC8-4A68-85B8-5691D541A5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8E4620-63A0-4FA7-97E3-9E3BD017B0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AAE0C5-028E-4C6C-96D0-D691E6634D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8809C6-3F71-498F-99D6-1C6CCEAE84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C68BD3-F8E1-478A-9022-A9341CBDF6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1D332-D1B5-412A-BD43-3D91AA662C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5998AF-EA5C-49C7-B141-7AF0E4A2061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EE2D85-3D38-42A3-831D-D90568425CDF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1600200" y="590400"/>
            <a:ext cx="5943600" cy="5796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upplemental Table S2  </a:t>
            </a:r>
            <a:br>
              <a:rPr sz="2200"/>
            </a:br>
            <a:r>
              <a:rPr b="0" lang="en-US" sz="2200" spc="-1" strike="noStrike">
                <a:solidFill>
                  <a:srgbClr val="000000"/>
                </a:solidFill>
                <a:latin typeface="Calibri"/>
              </a:rPr>
              <a:t>Summary of Intracellular Signaling Study</a:t>
            </a: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228600" y="1276200"/>
          <a:ext cx="8763120" cy="5346720"/>
        </p:xfrm>
        <a:graphic>
          <a:graphicData uri="http://schemas.openxmlformats.org/drawingml/2006/table">
            <a:tbl>
              <a:tblPr/>
              <a:tblGrid>
                <a:gridCol w="1122480"/>
                <a:gridCol w="884160"/>
                <a:gridCol w="1431720"/>
                <a:gridCol w="1467000"/>
                <a:gridCol w="1876320"/>
                <a:gridCol w="1981440"/>
              </a:tblGrid>
              <a:tr h="452520">
                <a:tc gridSpan="2" rowSpan="2">
                  <a:txBody>
                    <a:bodyPr lIns="90000" rIns="90000" anchor="t">
                      <a:noAutofit/>
                    </a:bodyPr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 row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u0063794 Treatmen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gridSpan="2"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msirolimus Treatmen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419040">
                <a:tc vMerge="1" gridSpan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vMerge="1"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ki-1 cell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86-O  cell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ki-1 cells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86-O  cell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695520">
                <a:tc gridSpan="2"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mTOR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r2448, Ser248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light decrea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just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light decrease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46080">
                <a:tc rowSpan="2"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ownstream of mTORC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70 S6K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hr389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4464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4E-BP1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er65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44640">
                <a:tc rowSpan="2"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ownstream of mTORC2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-Akt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hr308, Ser473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light decrease at 10 min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light increase at 30 min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nchanged at 1-3 hrs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Slight decrease at 10min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3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nchanged 30 min-3hrs</a:t>
                      </a:r>
                      <a:endParaRPr b="0" lang="en-US" sz="13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944280"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SK-</a:t>
                      </a:r>
                      <a:r>
                        <a:rPr b="0" lang="el-GR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α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/</a:t>
                      </a:r>
                      <a:r>
                        <a:rPr b="0" lang="el-GR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β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  <a:ea typeface="Times New Roman"/>
                        </a:rPr>
                        <a:t>Ser21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 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utes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   </a:t>
                      </a: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nM.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nchang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anchor="t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4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nchanged</a:t>
                      </a:r>
                      <a:endParaRPr b="0" lang="en-US" sz="1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Down Arrow 4"/>
          <p:cNvSpPr/>
          <p:nvPr/>
        </p:nvSpPr>
        <p:spPr>
          <a:xfrm>
            <a:off x="2362320" y="228132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Down Arrow 5"/>
          <p:cNvSpPr/>
          <p:nvPr/>
        </p:nvSpPr>
        <p:spPr>
          <a:xfrm>
            <a:off x="2362320" y="309564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Down Arrow 6"/>
          <p:cNvSpPr/>
          <p:nvPr/>
        </p:nvSpPr>
        <p:spPr>
          <a:xfrm>
            <a:off x="2362320" y="403848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Down Arrow 7"/>
          <p:cNvSpPr/>
          <p:nvPr/>
        </p:nvSpPr>
        <p:spPr>
          <a:xfrm>
            <a:off x="2362320" y="495288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Down Arrow 8"/>
          <p:cNvSpPr/>
          <p:nvPr/>
        </p:nvSpPr>
        <p:spPr>
          <a:xfrm>
            <a:off x="2362320" y="591984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Down Arrow 10"/>
          <p:cNvSpPr/>
          <p:nvPr/>
        </p:nvSpPr>
        <p:spPr>
          <a:xfrm>
            <a:off x="3809880" y="228132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Down Arrow 11"/>
          <p:cNvSpPr/>
          <p:nvPr/>
        </p:nvSpPr>
        <p:spPr>
          <a:xfrm>
            <a:off x="3786120" y="307188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Down Arrow 13"/>
          <p:cNvSpPr/>
          <p:nvPr/>
        </p:nvSpPr>
        <p:spPr>
          <a:xfrm>
            <a:off x="3800520" y="495288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Down Arrow 14"/>
          <p:cNvSpPr/>
          <p:nvPr/>
        </p:nvSpPr>
        <p:spPr>
          <a:xfrm>
            <a:off x="3792600" y="590220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Down Arrow 15"/>
          <p:cNvSpPr/>
          <p:nvPr/>
        </p:nvSpPr>
        <p:spPr>
          <a:xfrm>
            <a:off x="5334120" y="307188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Down Arrow 16"/>
          <p:cNvSpPr/>
          <p:nvPr/>
        </p:nvSpPr>
        <p:spPr>
          <a:xfrm>
            <a:off x="5338800" y="403848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Down Arrow 18"/>
          <p:cNvSpPr/>
          <p:nvPr/>
        </p:nvSpPr>
        <p:spPr>
          <a:xfrm>
            <a:off x="7280280" y="303048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Down Arrow 19"/>
          <p:cNvSpPr/>
          <p:nvPr/>
        </p:nvSpPr>
        <p:spPr>
          <a:xfrm>
            <a:off x="7304040" y="403848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Down Arrow 21"/>
          <p:cNvSpPr/>
          <p:nvPr/>
        </p:nvSpPr>
        <p:spPr>
          <a:xfrm>
            <a:off x="3800520" y="4065480"/>
            <a:ext cx="228600" cy="457200"/>
          </a:xfrm>
          <a:prstGeom prst="downArrow">
            <a:avLst>
              <a:gd name="adj1" fmla="val 50000"/>
              <a:gd name="adj2" fmla="val 50000"/>
            </a:avLst>
          </a:prstGeom>
          <a:solidFill>
            <a:srgbClr val="4f81bd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21T18:48:53Z</dcterms:created>
  <dc:creator>cshs</dc:creator>
  <dc:description/>
  <dc:language>en-US</dc:language>
  <cp:lastModifiedBy>Zhang, Hao</cp:lastModifiedBy>
  <dcterms:modified xsi:type="dcterms:W3CDTF">2012-12-22T22:55:16Z</dcterms:modified>
  <cp:revision>2</cp:revision>
  <dc:subject/>
  <dc:title>Supplemental Table 2   Summary of Intracellular Signaling Study</dc:title>
</cp:coreProperties>
</file>